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156"/>
    <p:restoredTop sz="71971"/>
  </p:normalViewPr>
  <p:slideViewPr>
    <p:cSldViewPr snapToGrid="0" snapToObjects="1">
      <p:cViewPr varScale="1">
        <p:scale>
          <a:sx n="55" d="100"/>
          <a:sy n="55" d="100"/>
        </p:scale>
        <p:origin x="192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FD9744-8BAA-114A-BAC3-25DA164A950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2F0825-FBA4-E54A-B43D-A048818FFA7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5746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</a:t>
            </a:r>
          </a:p>
          <a:p>
            <a:r>
              <a:rPr lang="en-US" altLang="zh-TW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gends: </a:t>
            </a:r>
            <a:r>
              <a:rPr lang="en-US" altLang="zh-TW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flowchart of the cases underwent oocyte thawing and embryo transfer cycles from the cryopreserved oocytes. ET: embryo transfer; PGT-A: preimplantation genetic testing for aneuploidy.</a:t>
            </a:r>
            <a:r>
              <a:rPr lang="zh-TW" altLang="zh-TW" dirty="0">
                <a:effectLst/>
              </a:rPr>
              <a:t> </a:t>
            </a:r>
            <a:endParaRPr kumimoji="1"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2F0825-FBA4-E54A-B43D-A048818FFA7A}" type="slidenum">
              <a:rPr kumimoji="1" lang="zh-TW" altLang="en-US" smtClean="0"/>
              <a:t>1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84176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3B946A8-C041-A04C-9D5C-A15AD4E3DA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3569E443-1C86-B347-893A-476A260245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2BDDEAD-F27F-4746-84FE-B624D2616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19B2070-AAC6-E34E-B059-8ECF135A7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A40E1C5-174E-2E48-8F77-7CAA6483A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153134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5A02DF6-B134-5240-99EB-31FC489F4A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5A1AB57C-DDFB-5646-BD65-263C2F4B24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A35AF26-8676-584E-811B-4FA2091AF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1402881-7FFC-F74A-BC2D-18043EA71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DC2356C-B1B3-6645-9FD1-4B7BA5A52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04766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40891B88-7613-094A-9DA8-7ADC66B09F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E8F1CDC4-97AA-8342-9901-9614E709C9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9261427-D991-1448-A3A0-C60F97D5A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8B59601-7268-B441-AC4C-AF349BB91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6241315-EB0E-9140-8BC2-6713B74F0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905996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583535A-91B0-D148-AC5E-0E1CDA0903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684D4E4-4059-5244-BB9E-F4850E503F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E738DEE-75B0-8048-B259-5A8EC700C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2F7754C-E35C-7A47-908D-7F6C8157F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081DF13-D171-AE47-8BF9-141556186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70303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DD7516D-057B-8F46-8782-A19C2BF6AD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74FF243-0E2D-5744-B7A7-6FAF2033B7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335F7C8-ED70-D84E-A020-34E5C4189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840B3D0-0038-A84C-9C89-4D51F88C6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50E9BDF-E3DC-2B47-B77D-AF2274A95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255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470622A-EB49-3447-91F0-F4A44C539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3A135063-FD9B-BD45-B07A-F4579874F0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A24A47A-DF45-F546-870C-AC2AE4DB2C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65BFDC0-26BB-794B-9DDF-6CFEFDDE0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10D80AF-B389-804A-A7A7-C4DC66B16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2F8A3BF3-C628-B14C-A826-FD67CFC8D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366621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3DCC1F4-1EC8-D64F-8EDB-1A2B6E93A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7942953E-2D99-454E-92C3-B06E5B04B8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7443B062-E55C-564D-A26B-E031A893EA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51BF8195-DA59-FA46-B4B1-6D567AAE5F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9ED9910E-6216-254D-86B4-CADB266209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E24F1B30-2AFC-334F-894A-DCBEE12D0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FB16EBC3-977D-B84D-A86B-DCE1FF481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D9CCF000-A5BF-D741-A6A3-D59A20052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665788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A9C8018-18CE-7C44-B64A-49F0145734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F72EEC84-A1C2-434F-9F09-7CBA4AECE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7A4FB22D-B08E-3844-ABCE-06DDF2465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376A9075-E64E-2447-86DB-FE311A241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006516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291DE10D-CD17-2F40-8690-069D22E52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F689751D-68CD-0E4E-A6DE-20DDA3FBB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7CD866F3-C594-734B-8F05-67DC438D4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55273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88C0E03-F0AE-4844-9E47-CF8058560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8F98333A-5488-4745-9E5F-E968C16331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2CA58C76-7D6A-524A-ABA9-4020E411CC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8AEF5C8-822E-7E4A-A477-F773766C8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6FEC6CD-99A8-C44A-8315-51F8CDDC1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E32E538-04D7-5D49-85F1-9FA33D7AC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69433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807425C-191A-484F-A27D-0BB3BFF27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F22CCE14-E97A-B04D-9A83-7BD0C5E2CE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5FD1990-A2C0-AF48-AC07-CFDBFFECE3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4A916D7-91E8-9440-8F35-60381D323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B620AC28-BB59-C041-8E90-ECB0A9D61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2E2498F-4617-8548-B711-9D0A4A49D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70443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9A65ABE0-D04B-1A49-A93E-4EC415796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5B8753D-8DF6-5A4D-9718-7CC03E275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4FB43BC-79F2-5D42-931D-8D19E3982E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4C7FE-AE4A-614B-B703-15B69D66169B}" type="datetimeFigureOut">
              <a:rPr kumimoji="1" lang="zh-TW" altLang="en-US" smtClean="0"/>
              <a:t>2022/7/1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B2770C8-9826-8F45-942A-1B26656726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CAD665A-74C6-1E4D-A067-27452D6088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9F0A8-09FA-0641-BBA0-941BFF83BCED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574281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>
            <a:extLst>
              <a:ext uri="{FF2B5EF4-FFF2-40B4-BE49-F238E27FC236}">
                <a16:creationId xmlns:a16="http://schemas.microsoft.com/office/drawing/2014/main" id="{AD5CBAE8-849F-C14E-98D5-E46CE0745356}"/>
              </a:ext>
            </a:extLst>
          </p:cNvPr>
          <p:cNvGrpSpPr/>
          <p:nvPr/>
        </p:nvGrpSpPr>
        <p:grpSpPr>
          <a:xfrm>
            <a:off x="1723291" y="348472"/>
            <a:ext cx="9096274" cy="6280928"/>
            <a:chOff x="123091" y="385971"/>
            <a:chExt cx="9096274" cy="6280928"/>
          </a:xfrm>
        </p:grpSpPr>
        <p:sp>
          <p:nvSpPr>
            <p:cNvPr id="5" name="文字方塊 4">
              <a:extLst>
                <a:ext uri="{FF2B5EF4-FFF2-40B4-BE49-F238E27FC236}">
                  <a16:creationId xmlns:a16="http://schemas.microsoft.com/office/drawing/2014/main" id="{026BB455-27C1-E040-92E5-360FBB41F7EE}"/>
                </a:ext>
              </a:extLst>
            </p:cNvPr>
            <p:cNvSpPr txBox="1"/>
            <p:nvPr/>
          </p:nvSpPr>
          <p:spPr>
            <a:xfrm>
              <a:off x="123091" y="967154"/>
              <a:ext cx="103906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Thaw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71 cycles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54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6" name="文字方塊 5">
              <a:extLst>
                <a:ext uri="{FF2B5EF4-FFF2-40B4-BE49-F238E27FC236}">
                  <a16:creationId xmlns:a16="http://schemas.microsoft.com/office/drawing/2014/main" id="{5A2BA80A-09A9-0047-9F1E-DCCE52409CFD}"/>
                </a:ext>
              </a:extLst>
            </p:cNvPr>
            <p:cNvSpPr txBox="1"/>
            <p:nvPr/>
          </p:nvSpPr>
          <p:spPr>
            <a:xfrm>
              <a:off x="6688584" y="993531"/>
              <a:ext cx="2398413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ET from thawed oocytes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52 cycles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41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7" name="文字方塊 6">
              <a:extLst>
                <a:ext uri="{FF2B5EF4-FFF2-40B4-BE49-F238E27FC236}">
                  <a16:creationId xmlns:a16="http://schemas.microsoft.com/office/drawing/2014/main" id="{142D8FC5-87AE-DD43-9172-D61A92D74CC0}"/>
                </a:ext>
              </a:extLst>
            </p:cNvPr>
            <p:cNvSpPr txBox="1"/>
            <p:nvPr/>
          </p:nvSpPr>
          <p:spPr>
            <a:xfrm>
              <a:off x="1785786" y="5799207"/>
              <a:ext cx="130997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Cancellation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5 cases</a:t>
              </a:r>
            </a:p>
          </p:txBody>
        </p:sp>
        <p:sp>
          <p:nvSpPr>
            <p:cNvPr id="8" name="文字方塊 7">
              <a:extLst>
                <a:ext uri="{FF2B5EF4-FFF2-40B4-BE49-F238E27FC236}">
                  <a16:creationId xmlns:a16="http://schemas.microsoft.com/office/drawing/2014/main" id="{E85089C6-5C30-5C4F-A17F-550891D09BC3}"/>
                </a:ext>
              </a:extLst>
            </p:cNvPr>
            <p:cNvSpPr txBox="1"/>
            <p:nvPr/>
          </p:nvSpPr>
          <p:spPr>
            <a:xfrm>
              <a:off x="1793630" y="4676467"/>
              <a:ext cx="205537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Switch to fresh cycle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3 cases</a:t>
              </a:r>
            </a:p>
          </p:txBody>
        </p:sp>
        <p:sp>
          <p:nvSpPr>
            <p:cNvPr id="9" name="文字方塊 8">
              <a:extLst>
                <a:ext uri="{FF2B5EF4-FFF2-40B4-BE49-F238E27FC236}">
                  <a16:creationId xmlns:a16="http://schemas.microsoft.com/office/drawing/2014/main" id="{8E457665-B413-AA48-8E93-CB922FA869B0}"/>
                </a:ext>
              </a:extLst>
            </p:cNvPr>
            <p:cNvSpPr txBox="1"/>
            <p:nvPr/>
          </p:nvSpPr>
          <p:spPr>
            <a:xfrm>
              <a:off x="1762257" y="3365285"/>
              <a:ext cx="175068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Fresh combined thawed oocytes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5 cases</a:t>
              </a:r>
              <a:endParaRPr lang="en-US" altLang="zh-TW" sz="105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cxnSp>
          <p:nvCxnSpPr>
            <p:cNvPr id="10" name="直線單箭頭接點 10">
              <a:extLst>
                <a:ext uri="{FF2B5EF4-FFF2-40B4-BE49-F238E27FC236}">
                  <a16:creationId xmlns:a16="http://schemas.microsoft.com/office/drawing/2014/main" id="{5B15FEA9-2812-FF4F-9E2B-5D97ADAC6920}"/>
                </a:ext>
              </a:extLst>
            </p:cNvPr>
            <p:cNvCxnSpPr>
              <a:stCxn id="5" idx="3"/>
              <a:endCxn id="6" idx="1"/>
            </p:cNvCxnSpPr>
            <p:nvPr/>
          </p:nvCxnSpPr>
          <p:spPr>
            <a:xfrm>
              <a:off x="1162158" y="1382653"/>
              <a:ext cx="5526426" cy="2637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字方塊 10">
              <a:extLst>
                <a:ext uri="{FF2B5EF4-FFF2-40B4-BE49-F238E27FC236}">
                  <a16:creationId xmlns:a16="http://schemas.microsoft.com/office/drawing/2014/main" id="{0EAC62D9-6748-004A-9BA5-F83A1216A054}"/>
                </a:ext>
              </a:extLst>
            </p:cNvPr>
            <p:cNvSpPr txBox="1"/>
            <p:nvPr/>
          </p:nvSpPr>
          <p:spPr>
            <a:xfrm>
              <a:off x="465876" y="4033004"/>
              <a:ext cx="100540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Exclude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13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12" name="文字方塊 11">
              <a:extLst>
                <a:ext uri="{FF2B5EF4-FFF2-40B4-BE49-F238E27FC236}">
                  <a16:creationId xmlns:a16="http://schemas.microsoft.com/office/drawing/2014/main" id="{C64FD434-0F8F-2D45-B764-1E7E588A6D59}"/>
                </a:ext>
              </a:extLst>
            </p:cNvPr>
            <p:cNvSpPr txBox="1"/>
            <p:nvPr/>
          </p:nvSpPr>
          <p:spPr>
            <a:xfrm>
              <a:off x="4048475" y="2304651"/>
              <a:ext cx="108395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Freeze all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3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13" name="文字方塊 12">
              <a:extLst>
                <a:ext uri="{FF2B5EF4-FFF2-40B4-BE49-F238E27FC236}">
                  <a16:creationId xmlns:a16="http://schemas.microsoft.com/office/drawing/2014/main" id="{CFB0A594-EEEF-2C41-A541-34666501F367}"/>
                </a:ext>
              </a:extLst>
            </p:cNvPr>
            <p:cNvSpPr txBox="1"/>
            <p:nvPr/>
          </p:nvSpPr>
          <p:spPr>
            <a:xfrm>
              <a:off x="2735677" y="385971"/>
              <a:ext cx="108395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Freeze all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1 cycle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6952EE4B-CEAB-E441-A561-BD6F66D4DD38}"/>
                </a:ext>
              </a:extLst>
            </p:cNvPr>
            <p:cNvSpPr txBox="1"/>
            <p:nvPr/>
          </p:nvSpPr>
          <p:spPr>
            <a:xfrm>
              <a:off x="4270522" y="504514"/>
              <a:ext cx="16546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Thawed embryo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cxnSp>
          <p:nvCxnSpPr>
            <p:cNvPr id="15" name="直線單箭頭接點 28">
              <a:extLst>
                <a:ext uri="{FF2B5EF4-FFF2-40B4-BE49-F238E27FC236}">
                  <a16:creationId xmlns:a16="http://schemas.microsoft.com/office/drawing/2014/main" id="{167286E3-8D55-F841-8C81-D85F22734D5C}"/>
                </a:ext>
              </a:extLst>
            </p:cNvPr>
            <p:cNvCxnSpPr>
              <a:cxnSpLocks/>
              <a:stCxn id="13" idx="3"/>
              <a:endCxn id="14" idx="1"/>
            </p:cNvCxnSpPr>
            <p:nvPr/>
          </p:nvCxnSpPr>
          <p:spPr>
            <a:xfrm flipV="1">
              <a:off x="3819628" y="673791"/>
              <a:ext cx="450894" cy="456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肘形接點 15">
              <a:extLst>
                <a:ext uri="{FF2B5EF4-FFF2-40B4-BE49-F238E27FC236}">
                  <a16:creationId xmlns:a16="http://schemas.microsoft.com/office/drawing/2014/main" id="{EEFF3EDA-D378-AD4A-AC2D-9AC6811C7C13}"/>
                </a:ext>
              </a:extLst>
            </p:cNvPr>
            <p:cNvCxnSpPr>
              <a:cxnSpLocks/>
              <a:endCxn id="13" idx="1"/>
            </p:cNvCxnSpPr>
            <p:nvPr/>
          </p:nvCxnSpPr>
          <p:spPr>
            <a:xfrm rot="5400000" flipH="1" flipV="1">
              <a:off x="2044059" y="691035"/>
              <a:ext cx="704294" cy="678942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肘形接點 16">
              <a:extLst>
                <a:ext uri="{FF2B5EF4-FFF2-40B4-BE49-F238E27FC236}">
                  <a16:creationId xmlns:a16="http://schemas.microsoft.com/office/drawing/2014/main" id="{91CB66A1-AD65-B241-87A5-DB2659CF0026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5730253" y="749798"/>
              <a:ext cx="694463" cy="543108"/>
            </a:xfrm>
            <a:prstGeom prst="bentConnector3">
              <a:avLst>
                <a:gd name="adj1" fmla="val -1434"/>
              </a:avLst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983EE50A-5F5C-564A-8268-1E2432A355D2}"/>
                </a:ext>
              </a:extLst>
            </p:cNvPr>
            <p:cNvSpPr txBox="1"/>
            <p:nvPr/>
          </p:nvSpPr>
          <p:spPr>
            <a:xfrm>
              <a:off x="6688584" y="3488396"/>
              <a:ext cx="193033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ET from both origin</a:t>
              </a:r>
            </a:p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4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cxnSp>
          <p:nvCxnSpPr>
            <p:cNvPr id="19" name="直線單箭頭接點 78">
              <a:extLst>
                <a:ext uri="{FF2B5EF4-FFF2-40B4-BE49-F238E27FC236}">
                  <a16:creationId xmlns:a16="http://schemas.microsoft.com/office/drawing/2014/main" id="{DB6932D7-BD0C-C64B-AE27-DE4F5BD03C47}"/>
                </a:ext>
              </a:extLst>
            </p:cNvPr>
            <p:cNvCxnSpPr>
              <a:cxnSpLocks/>
              <a:stCxn id="9" idx="3"/>
              <a:endCxn id="18" idx="1"/>
            </p:cNvCxnSpPr>
            <p:nvPr/>
          </p:nvCxnSpPr>
          <p:spPr>
            <a:xfrm>
              <a:off x="3512945" y="3780784"/>
              <a:ext cx="3175639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9A52983E-3ED9-3547-90B7-AC1C603DA2EF}"/>
                </a:ext>
              </a:extLst>
            </p:cNvPr>
            <p:cNvSpPr txBox="1"/>
            <p:nvPr/>
          </p:nvSpPr>
          <p:spPr>
            <a:xfrm>
              <a:off x="5415503" y="2889302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2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cxnSp>
          <p:nvCxnSpPr>
            <p:cNvPr id="21" name="肘形接點 20">
              <a:extLst>
                <a:ext uri="{FF2B5EF4-FFF2-40B4-BE49-F238E27FC236}">
                  <a16:creationId xmlns:a16="http://schemas.microsoft.com/office/drawing/2014/main" id="{6BA09DA1-0B9C-1D4B-9D87-B5EA24BA7B69}"/>
                </a:ext>
              </a:extLst>
            </p:cNvPr>
            <p:cNvCxnSpPr>
              <a:cxnSpLocks/>
              <a:endCxn id="12" idx="1"/>
            </p:cNvCxnSpPr>
            <p:nvPr/>
          </p:nvCxnSpPr>
          <p:spPr>
            <a:xfrm rot="5400000" flipH="1" flipV="1">
              <a:off x="3355754" y="3067486"/>
              <a:ext cx="1163167" cy="222275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線單箭頭接點 90">
              <a:extLst>
                <a:ext uri="{FF2B5EF4-FFF2-40B4-BE49-F238E27FC236}">
                  <a16:creationId xmlns:a16="http://schemas.microsoft.com/office/drawing/2014/main" id="{F195E508-FE58-A948-A06B-89E40432E8D7}"/>
                </a:ext>
              </a:extLst>
            </p:cNvPr>
            <p:cNvCxnSpPr>
              <a:cxnSpLocks/>
              <a:stCxn id="12" idx="3"/>
            </p:cNvCxnSpPr>
            <p:nvPr/>
          </p:nvCxnSpPr>
          <p:spPr>
            <a:xfrm>
              <a:off x="5132426" y="2597039"/>
              <a:ext cx="705181" cy="11631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肘形接點 22">
              <a:extLst>
                <a:ext uri="{FF2B5EF4-FFF2-40B4-BE49-F238E27FC236}">
                  <a16:creationId xmlns:a16="http://schemas.microsoft.com/office/drawing/2014/main" id="{436D2682-FF8F-AC40-BA28-2B3FB12FF53C}"/>
                </a:ext>
              </a:extLst>
            </p:cNvPr>
            <p:cNvCxnSpPr>
              <a:cxnSpLocks/>
              <a:endCxn id="9" idx="1"/>
            </p:cNvCxnSpPr>
            <p:nvPr/>
          </p:nvCxnSpPr>
          <p:spPr>
            <a:xfrm rot="16200000" flipH="1">
              <a:off x="418623" y="2437150"/>
              <a:ext cx="2371754" cy="315514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肘形接點 23">
              <a:extLst>
                <a:ext uri="{FF2B5EF4-FFF2-40B4-BE49-F238E27FC236}">
                  <a16:creationId xmlns:a16="http://schemas.microsoft.com/office/drawing/2014/main" id="{FB5E328C-E6DA-FE45-AB29-AF50375F6144}"/>
                </a:ext>
              </a:extLst>
            </p:cNvPr>
            <p:cNvCxnSpPr>
              <a:endCxn id="8" idx="1"/>
            </p:cNvCxnSpPr>
            <p:nvPr/>
          </p:nvCxnSpPr>
          <p:spPr>
            <a:xfrm rot="16200000" flipH="1">
              <a:off x="-149833" y="3025392"/>
              <a:ext cx="3540040" cy="346885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D57C4240-5D4A-C141-9781-49F0D321CA81}"/>
                </a:ext>
              </a:extLst>
            </p:cNvPr>
            <p:cNvSpPr txBox="1"/>
            <p:nvPr/>
          </p:nvSpPr>
          <p:spPr>
            <a:xfrm>
              <a:off x="3501582" y="5614197"/>
              <a:ext cx="35157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No normal fertilized embryo: 3 cases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41F08625-2C46-1446-AB01-F79F12324CE5}"/>
                </a:ext>
              </a:extLst>
            </p:cNvPr>
            <p:cNvSpPr txBox="1"/>
            <p:nvPr/>
          </p:nvSpPr>
          <p:spPr>
            <a:xfrm>
              <a:off x="3501582" y="5964481"/>
              <a:ext cx="47387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No blastocyst formation for embryo biopsy: 1 case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10FB33E1-1233-2348-A529-A979AEBF8F74}"/>
                </a:ext>
              </a:extLst>
            </p:cNvPr>
            <p:cNvSpPr txBox="1"/>
            <p:nvPr/>
          </p:nvSpPr>
          <p:spPr>
            <a:xfrm>
              <a:off x="3501582" y="6328345"/>
              <a:ext cx="37785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No euploid embryo after PGT-A: 1 case</a:t>
              </a:r>
              <a:endParaRPr lang="zh-TW" altLang="en-US" sz="1600" dirty="0">
                <a:latin typeface="Arial Unicode MS" panose="020B0604020202020204" pitchFamily="34" charset="-128"/>
                <a:ea typeface="Arial Unicode MS" panose="020B0604020202020204" pitchFamily="34" charset="-128"/>
                <a:cs typeface="Arial Unicode MS" panose="020B0604020202020204" pitchFamily="34" charset="-128"/>
              </a:endParaRPr>
            </a:p>
          </p:txBody>
        </p:sp>
        <p:cxnSp>
          <p:nvCxnSpPr>
            <p:cNvPr id="28" name="肘形接點 27">
              <a:extLst>
                <a:ext uri="{FF2B5EF4-FFF2-40B4-BE49-F238E27FC236}">
                  <a16:creationId xmlns:a16="http://schemas.microsoft.com/office/drawing/2014/main" id="{C7E56520-9998-664C-AA35-7A6720D2AE79}"/>
                </a:ext>
              </a:extLst>
            </p:cNvPr>
            <p:cNvCxnSpPr>
              <a:stCxn id="7" idx="3"/>
              <a:endCxn id="25" idx="1"/>
            </p:cNvCxnSpPr>
            <p:nvPr/>
          </p:nvCxnSpPr>
          <p:spPr>
            <a:xfrm flipV="1">
              <a:off x="3095760" y="5783474"/>
              <a:ext cx="405822" cy="308121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肘形接點 28">
              <a:extLst>
                <a:ext uri="{FF2B5EF4-FFF2-40B4-BE49-F238E27FC236}">
                  <a16:creationId xmlns:a16="http://schemas.microsoft.com/office/drawing/2014/main" id="{0A3E7177-EA08-3B49-9E79-A93B57257911}"/>
                </a:ext>
              </a:extLst>
            </p:cNvPr>
            <p:cNvCxnSpPr>
              <a:stCxn id="7" idx="3"/>
              <a:endCxn id="27" idx="1"/>
            </p:cNvCxnSpPr>
            <p:nvPr/>
          </p:nvCxnSpPr>
          <p:spPr>
            <a:xfrm>
              <a:off x="3095760" y="6091595"/>
              <a:ext cx="405822" cy="406027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肘形接點 29">
              <a:extLst>
                <a:ext uri="{FF2B5EF4-FFF2-40B4-BE49-F238E27FC236}">
                  <a16:creationId xmlns:a16="http://schemas.microsoft.com/office/drawing/2014/main" id="{254F84DE-1FF6-6845-954A-1EC91C8DFA5E}"/>
                </a:ext>
              </a:extLst>
            </p:cNvPr>
            <p:cNvCxnSpPr>
              <a:endCxn id="7" idx="1"/>
            </p:cNvCxnSpPr>
            <p:nvPr/>
          </p:nvCxnSpPr>
          <p:spPr>
            <a:xfrm rot="16200000" flipH="1">
              <a:off x="-715125" y="3590684"/>
              <a:ext cx="4662780" cy="339041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id="{AF90C286-62DC-194C-8A02-4907DB84F44B}"/>
                </a:ext>
              </a:extLst>
            </p:cNvPr>
            <p:cNvSpPr txBox="1"/>
            <p:nvPr/>
          </p:nvSpPr>
          <p:spPr>
            <a:xfrm>
              <a:off x="6626989" y="2437759"/>
              <a:ext cx="25923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dirty="0">
                  <a:latin typeface="Arial Unicode MS" panose="020B0604020202020204" pitchFamily="34" charset="-128"/>
                  <a:ea typeface="Arial Unicode MS" panose="020B0604020202020204" pitchFamily="34" charset="-128"/>
                  <a:cs typeface="Arial Unicode MS" panose="020B0604020202020204" pitchFamily="34" charset="-128"/>
                </a:rPr>
                <a:t>Not yet thawed ET: 1 case</a:t>
              </a:r>
            </a:p>
          </p:txBody>
        </p:sp>
        <p:cxnSp>
          <p:nvCxnSpPr>
            <p:cNvPr id="32" name="直線單箭頭接點 119">
              <a:extLst>
                <a:ext uri="{FF2B5EF4-FFF2-40B4-BE49-F238E27FC236}">
                  <a16:creationId xmlns:a16="http://schemas.microsoft.com/office/drawing/2014/main" id="{AD019DA3-E891-D243-9B17-E3B409A7070B}"/>
                </a:ext>
              </a:extLst>
            </p:cNvPr>
            <p:cNvCxnSpPr>
              <a:stCxn id="12" idx="3"/>
              <a:endCxn id="31" idx="1"/>
            </p:cNvCxnSpPr>
            <p:nvPr/>
          </p:nvCxnSpPr>
          <p:spPr>
            <a:xfrm>
              <a:off x="5132426" y="2597039"/>
              <a:ext cx="1494563" cy="999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02046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117</Words>
  <Application>Microsoft Macintosh PowerPoint</Application>
  <PresentationFormat>寬螢幕</PresentationFormat>
  <Paragraphs>29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 Unicode MS</vt:lpstr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. Jane</dc:creator>
  <cp:lastModifiedBy>. Jane</cp:lastModifiedBy>
  <cp:revision>9</cp:revision>
  <dcterms:created xsi:type="dcterms:W3CDTF">2022-07-17T02:08:33Z</dcterms:created>
  <dcterms:modified xsi:type="dcterms:W3CDTF">2022-07-17T09:15:47Z</dcterms:modified>
</cp:coreProperties>
</file>